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1FAD6-7531-4436-8426-8DBD74E3B8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9FDF2-CCA4-49D8-9C33-281B03D15C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CC61B-0ADF-4060-A6E2-DA61A8FA87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0711B-0518-49EC-92C3-0F5C05A9A6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3D871-6849-4278-9810-3DC9157C66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B2E14-AA49-413C-8F63-5FA0B4466A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CAEE6-291E-4E28-A1F7-3727E9EA27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58B25-5516-46FB-8305-1C1F5B49A5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ADDCA-C368-4DB6-B884-FF3999F9FA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9B6DF-31E8-4603-993A-8E6548FCC8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9084BD-8029-4614-B25D-705D7BC504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88621-5FF9-4C9E-B691-2F089EF5A7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2C9223-D4E9-4352-BE45-0B30441E1B8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006360" y="46368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995480" y="2071800"/>
            <a:ext cx="2865240" cy="5761080"/>
            <a:chOff x="1995480" y="2071800"/>
            <a:chExt cx="2865240" cy="5761080"/>
          </a:xfrm>
        </p:grpSpPr>
        <p:grpSp>
          <p:nvGrpSpPr>
            <p:cNvPr id="43" name=""/>
            <p:cNvGrpSpPr/>
            <p:nvPr/>
          </p:nvGrpSpPr>
          <p:grpSpPr>
            <a:xfrm>
              <a:off x="2081160" y="6603840"/>
              <a:ext cx="2649240" cy="1229040"/>
              <a:chOff x="2081160" y="6603840"/>
              <a:chExt cx="2649240" cy="1229040"/>
            </a:xfrm>
          </p:grpSpPr>
          <p:sp>
            <p:nvSpPr>
              <p:cNvPr id="44" name=""/>
              <p:cNvSpPr/>
              <p:nvPr/>
            </p:nvSpPr>
            <p:spPr>
              <a:xfrm>
                <a:off x="2393640" y="7226280"/>
                <a:ext cx="171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5" name="" descr=""/>
              <p:cNvPicPr/>
              <p:nvPr/>
            </p:nvPicPr>
            <p:blipFill>
              <a:blip r:embed="rId1">
                <a:lum contrast="24000"/>
              </a:blip>
              <a:srcRect l="-1170" t="13263" r="20402" b="0"/>
              <a:stretch/>
            </p:blipFill>
            <p:spPr>
              <a:xfrm>
                <a:off x="2463480" y="7091280"/>
                <a:ext cx="1619280" cy="281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"/>
              <p:cNvSpPr/>
              <p:nvPr/>
            </p:nvSpPr>
            <p:spPr>
              <a:xfrm>
                <a:off x="4006800" y="7066080"/>
                <a:ext cx="6624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(F1+LB1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753"/>
              <p:cNvSpPr/>
              <p:nvPr/>
            </p:nvSpPr>
            <p:spPr>
              <a:xfrm>
                <a:off x="2081160" y="715824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,0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rot="19131600">
                <a:off x="2453760" y="6771960"/>
                <a:ext cx="5695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-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 rot="19131600">
                <a:off x="2861640" y="6771960"/>
                <a:ext cx="5695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-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rot="19131600">
                <a:off x="3276360" y="6809760"/>
                <a:ext cx="4550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ol-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rot="19131600">
                <a:off x="3646080" y="6762600"/>
                <a:ext cx="5695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-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2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2487240" y="7396200"/>
                <a:ext cx="1582920" cy="436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"/>
              <p:cNvSpPr/>
              <p:nvPr/>
            </p:nvSpPr>
            <p:spPr>
              <a:xfrm>
                <a:off x="4025520" y="7437600"/>
                <a:ext cx="704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OT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(3D+REV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383920" y="7750080"/>
                <a:ext cx="173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753"/>
              <p:cNvSpPr/>
              <p:nvPr/>
            </p:nvSpPr>
            <p:spPr>
              <a:xfrm>
                <a:off x="2186280" y="767412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"/>
            <p:cNvSpPr/>
            <p:nvPr/>
          </p:nvSpPr>
          <p:spPr>
            <a:xfrm>
              <a:off x="1997280" y="50929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381040" y="6570720"/>
              <a:ext cx="173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376360" y="6174000"/>
              <a:ext cx="171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" descr=""/>
            <p:cNvPicPr/>
            <p:nvPr/>
          </p:nvPicPr>
          <p:blipFill>
            <a:blip r:embed="rId3">
              <a:lum contrast="24000"/>
            </a:blip>
            <a:srcRect l="0" t="0" r="21129" b="0"/>
            <a:stretch/>
          </p:blipFill>
          <p:spPr>
            <a:xfrm>
              <a:off x="2458800" y="5935680"/>
              <a:ext cx="1619280" cy="314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Text Box 728"/>
            <p:cNvSpPr/>
            <p:nvPr/>
          </p:nvSpPr>
          <p:spPr>
            <a:xfrm>
              <a:off x="2917440" y="5220000"/>
              <a:ext cx="479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N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AutoShape 725"/>
            <p:cNvSpPr/>
            <p:nvPr/>
          </p:nvSpPr>
          <p:spPr>
            <a:xfrm rot="16200000">
              <a:off x="3055680" y="4908600"/>
              <a:ext cx="198720" cy="1246320"/>
            </a:xfrm>
            <a:custGeom>
              <a:avLst/>
              <a:gdLst>
                <a:gd name="textAreaLeft" fmla="*/ 0 w 198720"/>
                <a:gd name="textAreaRight" fmla="*/ 71640 w 198720"/>
                <a:gd name="textAreaTop" fmla="*/ 28080 h 1246320"/>
                <a:gd name="textAreaBottom" fmla="*/ 1218240 h 124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781"/>
                    <a:pt x="10800" y="1561"/>
                  </a:cubicBezTo>
                  <a:lnTo>
                    <a:pt x="10800" y="9239"/>
                  </a:lnTo>
                  <a:cubicBezTo>
                    <a:pt x="10800" y="10020"/>
                    <a:pt x="16200" y="10800"/>
                    <a:pt x="21600" y="10800"/>
                  </a:cubicBezTo>
                  <a:cubicBezTo>
                    <a:pt x="16200" y="10800"/>
                    <a:pt x="10800" y="11581"/>
                    <a:pt x="10800" y="12361"/>
                  </a:cubicBezTo>
                  <a:lnTo>
                    <a:pt x="10800" y="20039"/>
                  </a:lnTo>
                  <a:cubicBezTo>
                    <a:pt x="10800" y="20820"/>
                    <a:pt x="5400" y="21600"/>
                    <a:pt x="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anchorCtr="1" vert="eaVer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038480" y="5938920"/>
              <a:ext cx="822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s-ES" sz="900" spc="-1" strike="noStrike">
                  <a:solidFill>
                    <a:srgbClr val="000000"/>
                  </a:solidFill>
                  <a:latin typeface="Arial"/>
                </a:rPr>
                <a:t>MDA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</a:rPr>
                <a:t>(F1+LBb1.3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9131600">
              <a:off x="2420640" y="5634000"/>
              <a:ext cx="569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</a:rPr>
                <a:t>mda1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9131600">
              <a:off x="2828880" y="5634000"/>
              <a:ext cx="569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</a:rPr>
                <a:t>mda1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9131600">
              <a:off x="3306960" y="5671440"/>
              <a:ext cx="455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ol-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728"/>
            <p:cNvSpPr/>
            <p:nvPr/>
          </p:nvSpPr>
          <p:spPr>
            <a:xfrm>
              <a:off x="3714480" y="5227920"/>
              <a:ext cx="485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gDN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9131600">
              <a:off x="3660480" y="5624280"/>
              <a:ext cx="569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</a:rPr>
                <a:t>mda1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AutoShape 725"/>
            <p:cNvSpPr/>
            <p:nvPr/>
          </p:nvSpPr>
          <p:spPr>
            <a:xfrm rot="16200000">
              <a:off x="3850200" y="5379120"/>
              <a:ext cx="196920" cy="312480"/>
            </a:xfrm>
            <a:custGeom>
              <a:avLst/>
              <a:gdLst>
                <a:gd name="textAreaLeft" fmla="*/ 0 w 196920"/>
                <a:gd name="textAreaRight" fmla="*/ 70920 w 196920"/>
                <a:gd name="textAreaTop" fmla="*/ 6840 h 312480"/>
                <a:gd name="textAreaBottom" fmla="*/ 305640 h 312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781"/>
                    <a:pt x="10800" y="1561"/>
                  </a:cubicBezTo>
                  <a:lnTo>
                    <a:pt x="10800" y="9239"/>
                  </a:lnTo>
                  <a:cubicBezTo>
                    <a:pt x="10800" y="10020"/>
                    <a:pt x="16200" y="10800"/>
                    <a:pt x="21600" y="10800"/>
                  </a:cubicBezTo>
                  <a:cubicBezTo>
                    <a:pt x="16200" y="10800"/>
                    <a:pt x="10800" y="11581"/>
                    <a:pt x="10800" y="12361"/>
                  </a:cubicBezTo>
                  <a:lnTo>
                    <a:pt x="10800" y="20039"/>
                  </a:lnTo>
                  <a:cubicBezTo>
                    <a:pt x="10800" y="20820"/>
                    <a:pt x="5400" y="21600"/>
                    <a:pt x="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 anchorCtr="1" vert="eaVer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755"/>
            <p:cNvSpPr/>
            <p:nvPr/>
          </p:nvSpPr>
          <p:spPr>
            <a:xfrm>
              <a:off x="2063880" y="609948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,5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" descr=""/>
            <p:cNvPicPr/>
            <p:nvPr/>
          </p:nvPicPr>
          <p:blipFill>
            <a:blip r:embed="rId4">
              <a:lum contrast="6000"/>
            </a:blip>
            <a:srcRect l="42876" t="9342" r="1693" b="19108"/>
            <a:stretch/>
          </p:blipFill>
          <p:spPr>
            <a:xfrm>
              <a:off x="2462040" y="6280200"/>
              <a:ext cx="1619280" cy="37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"/>
            <p:cNvSpPr/>
            <p:nvPr/>
          </p:nvSpPr>
          <p:spPr>
            <a:xfrm>
              <a:off x="4033800" y="6348600"/>
              <a:ext cx="704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Arial"/>
                </a:rPr>
                <a:t>OT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3D+REV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753"/>
            <p:cNvSpPr/>
            <p:nvPr/>
          </p:nvSpPr>
          <p:spPr>
            <a:xfrm>
              <a:off x="2183400" y="64947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3" name=""/>
            <p:cNvGrpSpPr/>
            <p:nvPr/>
          </p:nvGrpSpPr>
          <p:grpSpPr>
            <a:xfrm>
              <a:off x="1997280" y="3387960"/>
              <a:ext cx="2684160" cy="1676160"/>
              <a:chOff x="1997280" y="3387960"/>
              <a:chExt cx="2684160" cy="1676160"/>
            </a:xfrm>
          </p:grpSpPr>
          <p:sp>
            <p:nvSpPr>
              <p:cNvPr id="74" name=""/>
              <p:cNvSpPr/>
              <p:nvPr/>
            </p:nvSpPr>
            <p:spPr>
              <a:xfrm>
                <a:off x="2306520" y="4975560"/>
                <a:ext cx="173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305080" y="4465800"/>
                <a:ext cx="172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6" name="" descr=""/>
              <p:cNvPicPr/>
              <p:nvPr/>
            </p:nvPicPr>
            <p:blipFill>
              <a:blip r:embed="rId5"/>
              <a:srcRect l="36096" t="0" r="28852" b="0"/>
              <a:stretch/>
            </p:blipFill>
            <p:spPr>
              <a:xfrm>
                <a:off x="2398680" y="4284720"/>
                <a:ext cx="1619280" cy="31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" descr=""/>
              <p:cNvPicPr/>
              <p:nvPr/>
            </p:nvPicPr>
            <p:blipFill>
              <a:blip r:embed="rId6">
                <a:lum contrast="18000"/>
              </a:blip>
              <a:srcRect l="33575" t="8721" r="23023" b="20349"/>
              <a:stretch/>
            </p:blipFill>
            <p:spPr>
              <a:xfrm>
                <a:off x="2408040" y="4626000"/>
                <a:ext cx="1619280" cy="438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8" name=""/>
              <p:cNvSpPr/>
              <p:nvPr/>
            </p:nvSpPr>
            <p:spPr>
              <a:xfrm>
                <a:off x="3976200" y="4291200"/>
                <a:ext cx="692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(RP+R2a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rot="19131600">
                <a:off x="3189240" y="3971880"/>
                <a:ext cx="5695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-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rot="19131600">
                <a:off x="2719080" y="3981240"/>
                <a:ext cx="5695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mda1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rot="19131600">
                <a:off x="2374920" y="4009320"/>
                <a:ext cx="4550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ol-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rot="19131600">
                <a:off x="3627720" y="4009320"/>
                <a:ext cx="4550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ol-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3976560" y="4694400"/>
                <a:ext cx="704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Arial"/>
                  </a:rPr>
                  <a:t>OT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(3D+REV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 Box 728"/>
              <p:cNvSpPr/>
              <p:nvPr/>
            </p:nvSpPr>
            <p:spPr>
              <a:xfrm>
                <a:off x="2847600" y="3589560"/>
                <a:ext cx="4795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N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AutoShape 725"/>
              <p:cNvSpPr/>
              <p:nvPr/>
            </p:nvSpPr>
            <p:spPr>
              <a:xfrm rot="16200000">
                <a:off x="2979720" y="3244680"/>
                <a:ext cx="198360" cy="1265400"/>
              </a:xfrm>
              <a:custGeom>
                <a:avLst/>
                <a:gdLst>
                  <a:gd name="textAreaLeft" fmla="*/ 0 w 198360"/>
                  <a:gd name="textAreaRight" fmla="*/ 71640 w 198360"/>
                  <a:gd name="textAreaTop" fmla="*/ 28440 h 1265400"/>
                  <a:gd name="textAreaBottom" fmla="*/ 1236960 h 12654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781"/>
                      <a:pt x="10800" y="1561"/>
                    </a:cubicBezTo>
                    <a:lnTo>
                      <a:pt x="10800" y="9239"/>
                    </a:lnTo>
                    <a:cubicBezTo>
                      <a:pt x="10800" y="10020"/>
                      <a:pt x="16200" y="10800"/>
                      <a:pt x="21600" y="10800"/>
                    </a:cubicBezTo>
                    <a:cubicBezTo>
                      <a:pt x="16200" y="10800"/>
                      <a:pt x="10800" y="11581"/>
                      <a:pt x="10800" y="12361"/>
                    </a:cubicBezTo>
                    <a:lnTo>
                      <a:pt x="10800" y="20039"/>
                    </a:lnTo>
                    <a:cubicBezTo>
                      <a:pt x="10800" y="20820"/>
                      <a:pt x="54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 anchorCtr="1" vert="eaVer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 Box 728"/>
              <p:cNvSpPr/>
              <p:nvPr/>
            </p:nvSpPr>
            <p:spPr>
              <a:xfrm>
                <a:off x="3709800" y="3584880"/>
                <a:ext cx="485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DN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AutoShape 725"/>
              <p:cNvSpPr/>
              <p:nvPr/>
            </p:nvSpPr>
            <p:spPr>
              <a:xfrm rot="16200000">
                <a:off x="3838320" y="3692520"/>
                <a:ext cx="196560" cy="368280"/>
              </a:xfrm>
              <a:custGeom>
                <a:avLst/>
                <a:gdLst>
                  <a:gd name="textAreaLeft" fmla="*/ 0 w 196560"/>
                  <a:gd name="textAreaRight" fmla="*/ 70920 w 196560"/>
                  <a:gd name="textAreaTop" fmla="*/ 8280 h 368280"/>
                  <a:gd name="textAreaBottom" fmla="*/ 360000 h 368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781"/>
                      <a:pt x="10800" y="1561"/>
                    </a:cubicBezTo>
                    <a:lnTo>
                      <a:pt x="10800" y="9239"/>
                    </a:lnTo>
                    <a:cubicBezTo>
                      <a:pt x="10800" y="10020"/>
                      <a:pt x="16200" y="10800"/>
                      <a:pt x="21600" y="10800"/>
                    </a:cubicBezTo>
                    <a:cubicBezTo>
                      <a:pt x="16200" y="10800"/>
                      <a:pt x="10800" y="11581"/>
                      <a:pt x="10800" y="12361"/>
                    </a:cubicBezTo>
                    <a:lnTo>
                      <a:pt x="10800" y="20039"/>
                    </a:lnTo>
                    <a:cubicBezTo>
                      <a:pt x="10800" y="20820"/>
                      <a:pt x="54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 anchorCtr="1" vert="eaVer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997280" y="338796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753"/>
              <p:cNvSpPr/>
              <p:nvPr/>
            </p:nvSpPr>
            <p:spPr>
              <a:xfrm>
                <a:off x="2088000" y="438948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6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Rectangle 753"/>
              <p:cNvSpPr/>
              <p:nvPr/>
            </p:nvSpPr>
            <p:spPr>
              <a:xfrm>
                <a:off x="2089800" y="489924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" name="9 CuadroTexto"/>
            <p:cNvSpPr/>
            <p:nvPr/>
          </p:nvSpPr>
          <p:spPr>
            <a:xfrm>
              <a:off x="4075200" y="3219480"/>
              <a:ext cx="434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R2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" name=""/>
            <p:cNvGrpSpPr/>
            <p:nvPr/>
          </p:nvGrpSpPr>
          <p:grpSpPr>
            <a:xfrm>
              <a:off x="1995480" y="2071800"/>
              <a:ext cx="2499840" cy="1265040"/>
              <a:chOff x="1995480" y="2071800"/>
              <a:chExt cx="2499840" cy="1265040"/>
            </a:xfrm>
          </p:grpSpPr>
          <p:sp>
            <p:nvSpPr>
              <p:cNvPr id="93" name=""/>
              <p:cNvSpPr/>
              <p:nvPr/>
            </p:nvSpPr>
            <p:spPr>
              <a:xfrm>
                <a:off x="2013120" y="207180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4" name=""/>
              <p:cNvGrpSpPr/>
              <p:nvPr/>
            </p:nvGrpSpPr>
            <p:grpSpPr>
              <a:xfrm>
                <a:off x="1995480" y="2624400"/>
                <a:ext cx="2499840" cy="712440"/>
                <a:chOff x="1995480" y="2624400"/>
                <a:chExt cx="2499840" cy="712440"/>
              </a:xfrm>
            </p:grpSpPr>
            <p:sp>
              <p:nvSpPr>
                <p:cNvPr id="95" name="16 CuadroTexto"/>
                <p:cNvSpPr/>
                <p:nvPr/>
              </p:nvSpPr>
              <p:spPr>
                <a:xfrm>
                  <a:off x="3698640" y="2624400"/>
                  <a:ext cx="5490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mda1-1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5 CuadroTexto"/>
                <p:cNvSpPr/>
                <p:nvPr/>
              </p:nvSpPr>
              <p:spPr>
                <a:xfrm>
                  <a:off x="1995480" y="2749680"/>
                  <a:ext cx="11206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At4g14605 (</a:t>
                  </a:r>
                  <a:r>
                    <a:rPr b="0" i="1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MDA1</a:t>
                  </a:r>
                  <a:r>
                    <a:rPr b="0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)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6 CuadroTexto"/>
                <p:cNvSpPr/>
                <p:nvPr/>
              </p:nvSpPr>
              <p:spPr>
                <a:xfrm>
                  <a:off x="3203280" y="2624400"/>
                  <a:ext cx="5950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mda1-2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7 CuadroTexto"/>
                <p:cNvSpPr/>
                <p:nvPr/>
              </p:nvSpPr>
              <p:spPr>
                <a:xfrm>
                  <a:off x="3284280" y="2752920"/>
                  <a:ext cx="5140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LB1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8 CuadroTexto"/>
                <p:cNvSpPr/>
                <p:nvPr/>
              </p:nvSpPr>
              <p:spPr>
                <a:xfrm>
                  <a:off x="3017520" y="2978280"/>
                  <a:ext cx="3376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RP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00" name="11 Conector recto de flecha"/>
                <p:cNvCxnSpPr/>
                <p:nvPr/>
              </p:nvCxnSpPr>
              <p:spPr>
                <a:xfrm>
                  <a:off x="3241080" y="3090960"/>
                  <a:ext cx="12240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101" name="19 Conector recto"/>
                <p:cNvSpPr/>
                <p:nvPr/>
              </p:nvSpPr>
              <p:spPr>
                <a:xfrm>
                  <a:off x="2115720" y="3214800"/>
                  <a:ext cx="22795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20 Rectángulo"/>
                <p:cNvSpPr/>
                <p:nvPr/>
              </p:nvSpPr>
              <p:spPr>
                <a:xfrm>
                  <a:off x="2115720" y="3167280"/>
                  <a:ext cx="222120" cy="9684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21 Rectángulo"/>
                <p:cNvSpPr/>
                <p:nvPr/>
              </p:nvSpPr>
              <p:spPr>
                <a:xfrm>
                  <a:off x="2506320" y="3168720"/>
                  <a:ext cx="112320" cy="9684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22 Rectángulo"/>
                <p:cNvSpPr/>
                <p:nvPr/>
              </p:nvSpPr>
              <p:spPr>
                <a:xfrm>
                  <a:off x="2733480" y="3167280"/>
                  <a:ext cx="56880" cy="9684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23 Rectángulo"/>
                <p:cNvSpPr/>
                <p:nvPr/>
              </p:nvSpPr>
              <p:spPr>
                <a:xfrm>
                  <a:off x="2881080" y="3167280"/>
                  <a:ext cx="253800" cy="9684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24 Rectángulo"/>
                <p:cNvSpPr/>
                <p:nvPr/>
              </p:nvSpPr>
              <p:spPr>
                <a:xfrm>
                  <a:off x="3192120" y="3165480"/>
                  <a:ext cx="1112400" cy="9684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25 Pentágono"/>
                <p:cNvSpPr/>
                <p:nvPr/>
              </p:nvSpPr>
              <p:spPr>
                <a:xfrm>
                  <a:off x="4304880" y="3164040"/>
                  <a:ext cx="190440" cy="95040"/>
                </a:xfrm>
                <a:custGeom>
                  <a:avLst/>
                  <a:gdLst>
                    <a:gd name="textAreaLeft" fmla="*/ 0 w 190440"/>
                    <a:gd name="textAreaRight" fmla="*/ 190800 w 190440"/>
                    <a:gd name="textAreaTop" fmla="*/ 0 h 95040"/>
                    <a:gd name="textAreaBottom" fmla="*/ 95400 h 9504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80" y="0"/>
                      </a:lnTo>
                      <a:lnTo>
                        <a:pt x="21600" y="10800"/>
                      </a:lnTo>
                      <a:lnTo>
                        <a:pt x="16280" y="21600"/>
                      </a:lnTo>
                      <a:lnTo>
                        <a:pt x="0" y="216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28 Combinar"/>
                <p:cNvSpPr/>
                <p:nvPr/>
              </p:nvSpPr>
              <p:spPr>
                <a:xfrm>
                  <a:off x="3315960" y="2935440"/>
                  <a:ext cx="318960" cy="222120"/>
                </a:xfrm>
                <a:prstGeom prst="flowChartMerge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09" name="33 Conector recto de flecha"/>
                <p:cNvCxnSpPr/>
                <p:nvPr/>
              </p:nvCxnSpPr>
              <p:spPr>
                <a:xfrm flipH="1" flipV="1">
                  <a:off x="3996720" y="3334680"/>
                  <a:ext cx="127440" cy="25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cxnSp>
              <p:nvCxnSpPr>
                <p:cNvPr id="110" name="41 Conector recto de flecha"/>
                <p:cNvCxnSpPr/>
                <p:nvPr/>
              </p:nvCxnSpPr>
              <p:spPr>
                <a:xfrm flipH="1" flipV="1">
                  <a:off x="3315600" y="2881080"/>
                  <a:ext cx="127440" cy="216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111" name="52 Combinar"/>
                <p:cNvSpPr/>
                <p:nvPr/>
              </p:nvSpPr>
              <p:spPr>
                <a:xfrm>
                  <a:off x="3814560" y="2933640"/>
                  <a:ext cx="318600" cy="223920"/>
                </a:xfrm>
                <a:prstGeom prst="flowChartMerge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54 CuadroTexto"/>
                <p:cNvSpPr/>
                <p:nvPr/>
              </p:nvSpPr>
              <p:spPr>
                <a:xfrm>
                  <a:off x="3754080" y="2752920"/>
                  <a:ext cx="5983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900" spc="-1" strike="noStrike">
                      <a:solidFill>
                        <a:srgbClr val="000000"/>
                      </a:solidFill>
                      <a:latin typeface="Calibri"/>
                    </a:rPr>
                    <a:t>LBb1.3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13" name="41 Conector recto de flecha"/>
                <p:cNvCxnSpPr/>
                <p:nvPr/>
              </p:nvCxnSpPr>
              <p:spPr>
                <a:xfrm flipH="1" flipV="1">
                  <a:off x="3725280" y="2882160"/>
                  <a:ext cx="127440" cy="25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114" name="8 CuadroTexto"/>
                <p:cNvSpPr/>
                <p:nvPr/>
              </p:nvSpPr>
              <p:spPr>
                <a:xfrm>
                  <a:off x="2274480" y="2987640"/>
                  <a:ext cx="3380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F1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cxnSp>
              <p:nvCxnSpPr>
                <p:cNvPr id="115" name="11 Conector recto de flecha"/>
                <p:cNvCxnSpPr/>
                <p:nvPr/>
              </p:nvCxnSpPr>
              <p:spPr>
                <a:xfrm>
                  <a:off x="2498040" y="3099960"/>
                  <a:ext cx="122400" cy="2520"/>
                </a:xfrm>
                <a:prstGeom prst="straightConnector1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116" name="46 Rectángulo"/>
                <p:cNvSpPr/>
                <p:nvPr/>
              </p:nvSpPr>
              <p:spPr>
                <a:xfrm>
                  <a:off x="2474640" y="3167280"/>
                  <a:ext cx="45720" cy="1000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17" name="Rectangle 756"/>
            <p:cNvSpPr/>
            <p:nvPr/>
          </p:nvSpPr>
          <p:spPr>
            <a:xfrm>
              <a:off x="2169360" y="39466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b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07T12:18:19Z</dcterms:created>
  <dc:creator>vquesada</dc:creator>
  <dc:description/>
  <dc:language>en-US</dc:language>
  <cp:lastModifiedBy>vquesada</cp:lastModifiedBy>
  <dcterms:modified xsi:type="dcterms:W3CDTF">2012-04-24T14:24:52Z</dcterms:modified>
  <cp:revision>17</cp:revision>
  <dc:subject/>
  <dc:title>Diapositiva 1</dc:title>
</cp:coreProperties>
</file>